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5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0" roundtripDataSignature="AMtx7miOyp4AvHR7TXP32c8bkQiM7Dxi3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4F2DD76B-B8B0-43B5-AE02-9EE2643DA4F0}">
  <a:tblStyle styleId="{4F2DD76B-B8B0-43B5-AE02-9EE2643DA4F0}" styleName="Table_0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82447998-CF8B-45E6-A1C8-F19CBDA52353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80612"/>
  </p:normalViewPr>
  <p:slideViewPr>
    <p:cSldViewPr snapToGrid="0">
      <p:cViewPr varScale="1">
        <p:scale>
          <a:sx n="136" d="100"/>
          <a:sy n="136" d="100"/>
        </p:scale>
        <p:origin x="1504" y="1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20" Type="http://customschemas.google.com/relationships/presentationmetadata" Target="meta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creativecommons.org/licenses/by-nc-sa/2.0/" TargetMode="External"/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Google Shape;5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4" name="Google Shape;54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5875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rPr lang="en" dirty="0"/>
              <a:t>Image source: Author’s own image </a:t>
            </a:r>
            <a:endParaRPr dirty="0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10" name="Google Shape;110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Google Shape;116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17" name="Google Shape;117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3" name="Google Shape;123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lang="en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lang="en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rPr lang="en" dirty="0"/>
              <a:t>Image source: Early pregnancy fetal pole. In: The POCUS Atlas. https://</a:t>
            </a:r>
            <a:r>
              <a:rPr lang="en" dirty="0" err="1"/>
              <a:t>www.thepocusatlas.com</a:t>
            </a:r>
            <a:r>
              <a:rPr lang="en" dirty="0"/>
              <a:t>/</a:t>
            </a:r>
            <a:r>
              <a:rPr lang="en" dirty="0" err="1"/>
              <a:t>ea-obgyn?srsltid</a:t>
            </a:r>
            <a:r>
              <a:rPr lang="en" dirty="0"/>
              <a:t>=AfmBOopPVU0-3PAmGlXs8FXSMHv4FZ5yQObSy-c18KhXKAk1ikg7JT_z</a:t>
            </a:r>
            <a:r>
              <a:rPr lang="en" sz="1100" b="0" i="0" u="none" strike="noStrike" cap="none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. Accessed September 29, 2025. </a:t>
            </a:r>
            <a:r>
              <a:rPr lang="en" sz="11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 BY-NC 4.0</a:t>
            </a:r>
            <a:endParaRPr b="0" dirty="0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2" name="Google Shape;132;p1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0" name="Google Shape;60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5875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rPr lang="en" dirty="0"/>
              <a:t>Image Source: Kenny M. In: </a:t>
            </a:r>
            <a:r>
              <a:rPr lang="en" dirty="0" err="1"/>
              <a:t>flickr</a:t>
            </a:r>
            <a:r>
              <a:rPr lang="en" dirty="0"/>
              <a:t>. https://</a:t>
            </a:r>
            <a:r>
              <a:rPr lang="en" dirty="0" err="1"/>
              <a:t>www.flickr.com</a:t>
            </a:r>
            <a:r>
              <a:rPr lang="en" dirty="0"/>
              <a:t>/photos/</a:t>
            </a:r>
            <a:r>
              <a:rPr lang="en" dirty="0" err="1"/>
              <a:t>markkenny</a:t>
            </a:r>
            <a:r>
              <a:rPr lang="en" dirty="0"/>
              <a:t>/5089482375. Accessed September 29. 2025. </a:t>
            </a:r>
            <a:r>
              <a:rPr lang="en" sz="1100" b="0" i="0" u="sng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C BY-NC-SA 2.0</a:t>
            </a:r>
            <a:endParaRPr b="0" u="sng"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6" name="Google Shape;66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2" name="Google Shape;72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8" name="Google Shape;78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5" name="Google Shape;85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1" name="Google Shape;91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8" name="Google Shape;98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Google Shape;103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4" name="Google Shape;104;p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1" name="Google Shape;11;p1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2" name="Google Shape;12;p1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24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8" name="Google Shape;48;p24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9" name="Google Shape;49;p2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2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1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16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6" name="Google Shape;16;p16"/>
          <p:cNvSpPr txBox="1">
            <a:spLocks noGrp="1"/>
          </p:cNvSpPr>
          <p:nvPr>
            <p:ph type="dt" idx="10"/>
          </p:nvPr>
        </p:nvSpPr>
        <p:spPr>
          <a:xfrm>
            <a:off x="0" y="0"/>
            <a:ext cx="3000000" cy="300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7" name="Google Shape;17;p16"/>
          <p:cNvSpPr txBox="1">
            <a:spLocks noGrp="1"/>
          </p:cNvSpPr>
          <p:nvPr>
            <p:ph type="ftr" idx="11"/>
          </p:nvPr>
        </p:nvSpPr>
        <p:spPr>
          <a:xfrm>
            <a:off x="0" y="0"/>
            <a:ext cx="3000000" cy="300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8" name="Google Shape;18;p1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1pPr>
            <a:lvl2pPr marL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2pPr>
            <a:lvl3pPr marL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3pPr>
            <a:lvl4pPr marL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4pPr>
            <a:lvl5pPr marL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5pPr>
            <a:lvl6pPr marL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6pPr>
            <a:lvl7pPr marL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7pPr>
            <a:lvl8pPr marL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8pPr>
            <a:lvl9pPr marL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17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21" name="Google Shape;21;p1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23;p1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8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5" name="Google Shape;25;p18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6" name="Google Shape;26;p1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9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20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2" name="Google Shape;32;p20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3" name="Google Shape;33;p2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21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6" name="Google Shape;36;p2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2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9" name="Google Shape;39;p22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40" name="Google Shape;40;p22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41" name="Google Shape;41;p22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2" name="Google Shape;42;p2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23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5" name="Google Shape;45;p2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1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Char char="●"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p1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Left antecubital fossa</a:t>
            </a:r>
            <a:endParaRPr/>
          </a:p>
        </p:txBody>
      </p:sp>
      <p:pic>
        <p:nvPicPr>
          <p:cNvPr id="57" name="Google Shape;57;p1" descr="A close up of a scar&#10;&#10;AI-generated content may be incorrect.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 rot="5400000">
            <a:off x="2914650" y="642938"/>
            <a:ext cx="5143500" cy="38576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10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Junior Case B-Hcg</a:t>
            </a:r>
            <a:endParaRPr/>
          </a:p>
        </p:txBody>
      </p:sp>
      <p:sp>
        <p:nvSpPr>
          <p:cNvPr id="113" name="Google Shape;113;p10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1200"/>
              </a:spcAft>
              <a:buSzPts val="1800"/>
              <a:buNone/>
            </a:pPr>
            <a:endParaRPr/>
          </a:p>
        </p:txBody>
      </p:sp>
      <p:graphicFrame>
        <p:nvGraphicFramePr>
          <p:cNvPr id="114" name="Google Shape;114;p10"/>
          <p:cNvGraphicFramePr/>
          <p:nvPr/>
        </p:nvGraphicFramePr>
        <p:xfrm>
          <a:off x="460900" y="1265950"/>
          <a:ext cx="3000000" cy="3000000"/>
        </p:xfrm>
        <a:graphic>
          <a:graphicData uri="http://schemas.openxmlformats.org/drawingml/2006/table">
            <a:tbl>
              <a:tblPr>
                <a:noFill/>
                <a:tableStyleId>{4F2DD76B-B8B0-43B5-AE02-9EE2643DA4F0}</a:tableStyleId>
              </a:tblPr>
              <a:tblGrid>
                <a:gridCol w="2775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47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-Hcg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&lt;1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egative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1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Senior Case B-Hcg</a:t>
            </a:r>
            <a:endParaRPr/>
          </a:p>
        </p:txBody>
      </p:sp>
      <p:graphicFrame>
        <p:nvGraphicFramePr>
          <p:cNvPr id="120" name="Google Shape;120;p11"/>
          <p:cNvGraphicFramePr/>
          <p:nvPr/>
        </p:nvGraphicFramePr>
        <p:xfrm>
          <a:off x="460900" y="1265950"/>
          <a:ext cx="3000000" cy="3000000"/>
        </p:xfrm>
        <a:graphic>
          <a:graphicData uri="http://schemas.openxmlformats.org/drawingml/2006/table">
            <a:tbl>
              <a:tblPr>
                <a:noFill/>
                <a:tableStyleId>{82447998-CF8B-45E6-A1C8-F19CBDA52353}</a:tableStyleId>
              </a:tblPr>
              <a:tblGrid>
                <a:gridCol w="2775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47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-Hcg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8,000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egative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Google Shape;125;p12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Senior Case US Pelvis</a:t>
            </a:r>
            <a:endParaRPr/>
          </a:p>
        </p:txBody>
      </p:sp>
      <p:sp>
        <p:nvSpPr>
          <p:cNvPr id="126" name="Google Shape;126;p12"/>
          <p:cNvSpPr/>
          <p:nvPr/>
        </p:nvSpPr>
        <p:spPr>
          <a:xfrm>
            <a:off x="4080681" y="2674960"/>
            <a:ext cx="423079" cy="87859"/>
          </a:xfrm>
          <a:prstGeom prst="rect">
            <a:avLst/>
          </a:prstGeom>
          <a:solidFill>
            <a:schemeClr val="dk1"/>
          </a:solidFill>
          <a:ln w="254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27" name="Google Shape;127;p12"/>
          <p:cNvGrpSpPr/>
          <p:nvPr/>
        </p:nvGrpSpPr>
        <p:grpSpPr>
          <a:xfrm>
            <a:off x="2342459" y="1097792"/>
            <a:ext cx="4045708" cy="4045708"/>
            <a:chOff x="2860059" y="1097792"/>
            <a:chExt cx="4045708" cy="4045708"/>
          </a:xfrm>
        </p:grpSpPr>
        <p:pic>
          <p:nvPicPr>
            <p:cNvPr id="128" name="Google Shape;128;p12" descr="Early Pregnancy: Fetal Pole 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2860059" y="1097792"/>
              <a:ext cx="4045708" cy="404570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9" name="Google Shape;129;p12"/>
            <p:cNvSpPr txBox="1"/>
            <p:nvPr/>
          </p:nvSpPr>
          <p:spPr>
            <a:xfrm>
              <a:off x="5555425" y="3761125"/>
              <a:ext cx="966300" cy="460200"/>
            </a:xfrm>
            <a:prstGeom prst="rect">
              <a:avLst/>
            </a:prstGeom>
            <a:solidFill>
              <a:schemeClr val="lt1"/>
            </a:solidFill>
            <a:ln w="9525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000">
                  <a:solidFill>
                    <a:schemeClr val="dk2"/>
                  </a:solidFill>
                </a:rPr>
                <a:t>FHR 176</a:t>
              </a:r>
              <a:endParaRPr sz="1000">
                <a:solidFill>
                  <a:schemeClr val="dk2"/>
                </a:solidFill>
              </a:endParaRPr>
            </a:p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000">
                  <a:solidFill>
                    <a:schemeClr val="dk2"/>
                  </a:solidFill>
                </a:rPr>
                <a:t>EGA 7.4wks</a:t>
              </a:r>
              <a:endParaRPr sz="1000">
                <a:solidFill>
                  <a:schemeClr val="dk2"/>
                </a:solidFill>
              </a:endParaRPr>
            </a:p>
          </p:txBody>
        </p:sp>
      </p:grp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13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Senior Case Type and Screen</a:t>
            </a:r>
            <a:endParaRPr/>
          </a:p>
        </p:txBody>
      </p:sp>
      <p:graphicFrame>
        <p:nvGraphicFramePr>
          <p:cNvPr id="135" name="Google Shape;135;p13"/>
          <p:cNvGraphicFramePr/>
          <p:nvPr/>
        </p:nvGraphicFramePr>
        <p:xfrm>
          <a:off x="460900" y="1265950"/>
          <a:ext cx="3000000" cy="3000000"/>
        </p:xfrm>
        <a:graphic>
          <a:graphicData uri="http://schemas.openxmlformats.org/drawingml/2006/table">
            <a:tbl>
              <a:tblPr>
                <a:noFill/>
                <a:tableStyleId>{82447998-CF8B-45E6-A1C8-F19CBDA52353}</a:tableStyleId>
              </a:tblPr>
              <a:tblGrid>
                <a:gridCol w="2775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47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lood typ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O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, B, O, AB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h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ositive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ositive, Negative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Left Medial Leg</a:t>
            </a:r>
            <a:endParaRPr/>
          </a:p>
        </p:txBody>
      </p:sp>
      <p:pic>
        <p:nvPicPr>
          <p:cNvPr id="63" name="Google Shape;63;p2" descr="A bruise on a person's leg&#10;&#10;AI-generated content may be incorrect.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29050" y="944708"/>
            <a:ext cx="6304345" cy="419879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Google Shape;68;p3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Point of Care Glucose </a:t>
            </a:r>
            <a:endParaRPr/>
          </a:p>
        </p:txBody>
      </p:sp>
      <p:graphicFrame>
        <p:nvGraphicFramePr>
          <p:cNvPr id="69" name="Google Shape;69;p3"/>
          <p:cNvGraphicFramePr/>
          <p:nvPr/>
        </p:nvGraphicFramePr>
        <p:xfrm>
          <a:off x="433980" y="2066925"/>
          <a:ext cx="7774550" cy="1559700"/>
        </p:xfrm>
        <a:graphic>
          <a:graphicData uri="http://schemas.openxmlformats.org/drawingml/2006/table">
            <a:tbl>
              <a:tblPr>
                <a:noFill/>
                <a:tableStyleId>{4F2DD76B-B8B0-43B5-AE02-9EE2643DA4F0}</a:tableStyleId>
              </a:tblPr>
              <a:tblGrid>
                <a:gridCol w="2588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88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969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412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185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OC Glucos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0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0-125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Google Shape;74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CBC</a:t>
            </a:r>
            <a:endParaRPr/>
          </a:p>
        </p:txBody>
      </p:sp>
      <p:graphicFrame>
        <p:nvGraphicFramePr>
          <p:cNvPr id="75" name="Google Shape;75;p4"/>
          <p:cNvGraphicFramePr/>
          <p:nvPr/>
        </p:nvGraphicFramePr>
        <p:xfrm>
          <a:off x="684724" y="1152475"/>
          <a:ext cx="8147600" cy="3618377"/>
        </p:xfrm>
        <a:graphic>
          <a:graphicData uri="http://schemas.openxmlformats.org/drawingml/2006/table">
            <a:tbl>
              <a:tblPr>
                <a:noFill/>
                <a:tableStyleId>{4F2DD76B-B8B0-43B5-AE02-9EE2643DA4F0}</a:tableStyleId>
              </a:tblPr>
              <a:tblGrid>
                <a:gridCol w="2713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130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215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412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185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WBC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,200 cells/mm</a:t>
                      </a:r>
                      <a:r>
                        <a:rPr lang="en" sz="2800" u="none" strike="noStrike" cap="none" baseline="3000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,000-10,000 cells/mm</a:t>
                      </a:r>
                      <a:r>
                        <a:rPr lang="en" sz="2800" u="none" strike="noStrike" cap="none" baseline="3000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412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GB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.9 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2-14 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412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CT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5 %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1-50%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412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lts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76x103/mm</a:t>
                      </a:r>
                      <a:r>
                        <a:rPr lang="en" sz="2800" u="none" strike="noStrike" cap="none" baseline="3000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2800" u="none" strike="noStrike" cap="none" baseline="3000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0-300x103mm</a:t>
                      </a:r>
                      <a:r>
                        <a:rPr lang="en" sz="2800" u="none" strike="noStrike" cap="none" baseline="3000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Google Shape;80;p5"/>
          <p:cNvSpPr txBox="1">
            <a:spLocks noGrp="1"/>
          </p:cNvSpPr>
          <p:nvPr>
            <p:ph type="title"/>
          </p:nvPr>
        </p:nvSpPr>
        <p:spPr>
          <a:xfrm>
            <a:off x="311700" y="186350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</a:pPr>
            <a:r>
              <a:rPr lang="en" sz="2500"/>
              <a:t>BMP</a:t>
            </a:r>
            <a:endParaRPr sz="2500"/>
          </a:p>
        </p:txBody>
      </p:sp>
      <p:sp>
        <p:nvSpPr>
          <p:cNvPr id="81" name="Google Shape;81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1200"/>
              </a:spcAft>
              <a:buSzPts val="1800"/>
              <a:buNone/>
            </a:pPr>
            <a:endParaRPr sz="1500"/>
          </a:p>
        </p:txBody>
      </p:sp>
      <p:graphicFrame>
        <p:nvGraphicFramePr>
          <p:cNvPr id="82" name="Google Shape;82;p5"/>
          <p:cNvGraphicFramePr/>
          <p:nvPr/>
        </p:nvGraphicFramePr>
        <p:xfrm>
          <a:off x="1378424" y="454358"/>
          <a:ext cx="7192375" cy="4502792"/>
        </p:xfrm>
        <a:graphic>
          <a:graphicData uri="http://schemas.openxmlformats.org/drawingml/2006/table">
            <a:tbl>
              <a:tblPr>
                <a:noFill/>
                <a:tableStyleId>{4F2DD76B-B8B0-43B5-AE02-9EE2643DA4F0}</a:tableStyleId>
              </a:tblPr>
              <a:tblGrid>
                <a:gridCol w="24099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87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949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a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35 mEq/L 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34-145 mEq/L 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lorid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1 mEq/L 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8-107 mEq/L 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un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6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-25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r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75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5-1.4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CO3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4 mEq/L 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2-34 mEq/L 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lucos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2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0-120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otassium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.7 mEq/L 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.5-4.5 mEq/L </a:t>
                      </a:r>
                      <a:endParaRPr/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Electrolytes</a:t>
            </a:r>
            <a:endParaRPr/>
          </a:p>
        </p:txBody>
      </p:sp>
      <p:graphicFrame>
        <p:nvGraphicFramePr>
          <p:cNvPr id="88" name="Google Shape;88;p6"/>
          <p:cNvGraphicFramePr/>
          <p:nvPr/>
        </p:nvGraphicFramePr>
        <p:xfrm>
          <a:off x="460900" y="1265950"/>
          <a:ext cx="8222200" cy="3562625"/>
        </p:xfrm>
        <a:graphic>
          <a:graphicData uri="http://schemas.openxmlformats.org/drawingml/2006/table">
            <a:tbl>
              <a:tblPr>
                <a:noFill/>
                <a:tableStyleId>{4F2DD76B-B8B0-43B5-AE02-9EE2643DA4F0}</a:tableStyleId>
              </a:tblPr>
              <a:tblGrid>
                <a:gridCol w="2775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47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alcium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.9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.6-10.3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agnesium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1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9-2.7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hosphorous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.2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5-5.0 mg/dL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7"/>
          <p:cNvSpPr txBox="1">
            <a:spLocks noGrp="1"/>
          </p:cNvSpPr>
          <p:nvPr>
            <p:ph type="title"/>
          </p:nvPr>
        </p:nvSpPr>
        <p:spPr>
          <a:xfrm>
            <a:off x="311700" y="186350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</a:pPr>
            <a:r>
              <a:rPr lang="en" sz="2500"/>
              <a:t>UA</a:t>
            </a:r>
            <a:endParaRPr sz="2500"/>
          </a:p>
        </p:txBody>
      </p:sp>
      <p:sp>
        <p:nvSpPr>
          <p:cNvPr id="94" name="Google Shape;94;p7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1200"/>
              </a:spcAft>
              <a:buSzPts val="1800"/>
              <a:buNone/>
            </a:pPr>
            <a:endParaRPr sz="1500"/>
          </a:p>
        </p:txBody>
      </p:sp>
      <p:graphicFrame>
        <p:nvGraphicFramePr>
          <p:cNvPr id="95" name="Google Shape;95;p7"/>
          <p:cNvGraphicFramePr/>
          <p:nvPr/>
        </p:nvGraphicFramePr>
        <p:xfrm>
          <a:off x="1337479" y="0"/>
          <a:ext cx="3000000" cy="3000000"/>
        </p:xfrm>
        <a:graphic>
          <a:graphicData uri="http://schemas.openxmlformats.org/drawingml/2006/table">
            <a:tbl>
              <a:tblPr>
                <a:noFill/>
                <a:tableStyleId>{4F2DD76B-B8B0-43B5-AE02-9EE2643DA4F0}</a:tableStyleId>
              </a:tblPr>
              <a:tblGrid>
                <a:gridCol w="2551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279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358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Urinalysis 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eference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H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-9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ecific Gravity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015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000-1.060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lucose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 mg/dL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&lt;20 mg/dL 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rotein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</a:t>
                      </a: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mg/dL</a:t>
                      </a:r>
                      <a:endParaRPr/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&lt;20 mg/dL </a:t>
                      </a:r>
                      <a:endParaRPr/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Urobilinogen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 mg/dL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&lt;1.6 mg/dL </a:t>
                      </a:r>
                      <a:endParaRPr/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lood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 mg/dL</a:t>
                      </a:r>
                      <a:endParaRPr/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&lt;0.02 mg/dL </a:t>
                      </a:r>
                      <a:endParaRPr/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Ketone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 mg/dL</a:t>
                      </a:r>
                      <a:endParaRPr/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&lt;3 mg/dL </a:t>
                      </a:r>
                      <a:endParaRPr/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itrite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egative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-1 mg/dL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12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Leukocytes</a:t>
                      </a:r>
                      <a:endParaRPr sz="24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5</a:t>
                      </a: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WBCs/uL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400"/>
                        <a:buFont typeface="Arial"/>
                        <a:buNone/>
                      </a:pPr>
                      <a:r>
                        <a:rPr lang="en" sz="24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5-40 WBCs/uL</a:t>
                      </a:r>
                      <a:endParaRPr sz="2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VDRL/RPR</a:t>
            </a:r>
            <a:endParaRPr/>
          </a:p>
        </p:txBody>
      </p:sp>
      <p:graphicFrame>
        <p:nvGraphicFramePr>
          <p:cNvPr id="101" name="Google Shape;101;p8"/>
          <p:cNvGraphicFramePr/>
          <p:nvPr/>
        </p:nvGraphicFramePr>
        <p:xfrm>
          <a:off x="460900" y="1419367"/>
          <a:ext cx="3000000" cy="3000000"/>
        </p:xfrm>
        <a:graphic>
          <a:graphicData uri="http://schemas.openxmlformats.org/drawingml/2006/table">
            <a:tbl>
              <a:tblPr>
                <a:noFill/>
                <a:tableStyleId>{4F2DD76B-B8B0-43B5-AE02-9EE2643DA4F0}</a:tableStyleId>
              </a:tblPr>
              <a:tblGrid>
                <a:gridCol w="2775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943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VDRL/RPR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egative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egative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9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11111"/>
              <a:buNone/>
            </a:pPr>
            <a:r>
              <a:rPr lang="en"/>
              <a:t>Rapid HIV</a:t>
            </a:r>
            <a:endParaRPr/>
          </a:p>
        </p:txBody>
      </p:sp>
      <p:graphicFrame>
        <p:nvGraphicFramePr>
          <p:cNvPr id="107" name="Google Shape;107;p9"/>
          <p:cNvGraphicFramePr/>
          <p:nvPr/>
        </p:nvGraphicFramePr>
        <p:xfrm>
          <a:off x="460900" y="1419367"/>
          <a:ext cx="3000000" cy="3000000"/>
        </p:xfrm>
        <a:graphic>
          <a:graphicData uri="http://schemas.openxmlformats.org/drawingml/2006/table">
            <a:tbl>
              <a:tblPr>
                <a:noFill/>
                <a:tableStyleId>{4F2DD76B-B8B0-43B5-AE02-9EE2643DA4F0}</a:tableStyleId>
              </a:tblPr>
              <a:tblGrid>
                <a:gridCol w="2775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23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943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atient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rmal value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71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b="1" u="none" strike="noStrike" cap="non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apid HIV</a:t>
                      </a:r>
                      <a:endParaRPr sz="2800" b="1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egative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2800"/>
                        <a:buFont typeface="Arial"/>
                        <a:buNone/>
                      </a:pPr>
                      <a:r>
                        <a:rPr lang="en" sz="2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egative</a:t>
                      </a:r>
                      <a:endParaRPr sz="2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68575" marR="68575" marT="9525" marB="91425">
                    <a:lnL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FFFFFF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8</Words>
  <Application>Microsoft Macintosh PowerPoint</Application>
  <PresentationFormat>On-screen Show (16:9)</PresentationFormat>
  <Paragraphs>131</Paragraphs>
  <Slides>13</Slides>
  <Notes>1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6" baseType="lpstr">
      <vt:lpstr>Arial</vt:lpstr>
      <vt:lpstr>Calibri</vt:lpstr>
      <vt:lpstr>Simple Light</vt:lpstr>
      <vt:lpstr>Left antecubital fossa</vt:lpstr>
      <vt:lpstr>Left Medial Leg</vt:lpstr>
      <vt:lpstr>Point of Care Glucose </vt:lpstr>
      <vt:lpstr>CBC</vt:lpstr>
      <vt:lpstr>BMP</vt:lpstr>
      <vt:lpstr>Electrolytes</vt:lpstr>
      <vt:lpstr>UA</vt:lpstr>
      <vt:lpstr>VDRL/RPR</vt:lpstr>
      <vt:lpstr>Rapid HIV</vt:lpstr>
      <vt:lpstr>Junior Case B-Hcg</vt:lpstr>
      <vt:lpstr>Senior Case B-Hcg</vt:lpstr>
      <vt:lpstr>Senior Case US Pelvis</vt:lpstr>
      <vt:lpstr>Senior Case Type and Scree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Toohey, Shannon</cp:lastModifiedBy>
  <cp:revision>2</cp:revision>
  <dcterms:modified xsi:type="dcterms:W3CDTF">2025-10-03T14:12:27Z</dcterms:modified>
</cp:coreProperties>
</file>